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-1680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24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wanxia\Desktop\manuscript%20of%20pyf\&#19975;&#38686;&#32769;&#24072;&#33639;&#20809;&#23450;&#37327;&#23454;&#39564;&#32467;&#26524;--2016.1.24\&#33639;&#20809;&#23450;&#37327;%20&#27719;&#24635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44685039370074"/>
          <c:y val="5.1400554097404488E-2"/>
          <c:w val="0.87870734908136461"/>
          <c:h val="0.855767716535433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43</c:f>
              <c:strCache>
                <c:ptCount val="1"/>
                <c:pt idx="0">
                  <c:v>pDHA-pfaABCD+pfaE(DHA)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B$49:$F$49</c:f>
                <c:numCache>
                  <c:formatCode>General</c:formatCode>
                  <c:ptCount val="5"/>
                  <c:pt idx="0">
                    <c:v>0.7379308992231981</c:v>
                  </c:pt>
                  <c:pt idx="1">
                    <c:v>0.47719725962983922</c:v>
                  </c:pt>
                  <c:pt idx="2">
                    <c:v>0.26634909388287192</c:v>
                  </c:pt>
                  <c:pt idx="3">
                    <c:v>0.31674284339159131</c:v>
                  </c:pt>
                  <c:pt idx="4">
                    <c:v>0.42293856374410083</c:v>
                  </c:pt>
                </c:numCache>
              </c:numRef>
            </c:plus>
          </c:errBars>
          <c:cat>
            <c:strRef>
              <c:f>Sheet1!$B$42:$F$42</c:f>
              <c:strCache>
                <c:ptCount val="5"/>
                <c:pt idx="0">
                  <c:v>pfaA</c:v>
                </c:pt>
                <c:pt idx="1">
                  <c:v>pfaB</c:v>
                </c:pt>
                <c:pt idx="2">
                  <c:v>pfaC</c:v>
                </c:pt>
                <c:pt idx="3">
                  <c:v>pfaD</c:v>
                </c:pt>
                <c:pt idx="4">
                  <c:v>pfaE</c:v>
                </c:pt>
              </c:strCache>
            </c:strRef>
          </c:cat>
          <c:val>
            <c:numRef>
              <c:f>Sheet1!$B$43:$F$43</c:f>
              <c:numCache>
                <c:formatCode>0.00_);[Red]\(0.00\)</c:formatCode>
                <c:ptCount val="5"/>
                <c:pt idx="0">
                  <c:v>2.7534038070833082</c:v>
                </c:pt>
                <c:pt idx="1">
                  <c:v>2.4697041690073172</c:v>
                </c:pt>
                <c:pt idx="2">
                  <c:v>1.224813404942332</c:v>
                </c:pt>
                <c:pt idx="3">
                  <c:v>1.8595848282660821</c:v>
                </c:pt>
                <c:pt idx="4">
                  <c:v>1.4282303655138</c:v>
                </c:pt>
              </c:numCache>
            </c:numRef>
          </c:val>
        </c:ser>
        <c:ser>
          <c:idx val="1"/>
          <c:order val="1"/>
          <c:tx>
            <c:strRef>
              <c:f>Sheet1!$A$44</c:f>
              <c:strCache>
                <c:ptCount val="1"/>
                <c:pt idx="0">
                  <c:v>pDHA-pfaABCD+pfaE(DHA-M)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B$50:$F$50</c:f>
                <c:numCache>
                  <c:formatCode>General</c:formatCode>
                  <c:ptCount val="5"/>
                  <c:pt idx="0">
                    <c:v>0.13460456467157367</c:v>
                  </c:pt>
                  <c:pt idx="1">
                    <c:v>0.11286880969822048</c:v>
                  </c:pt>
                  <c:pt idx="2">
                    <c:v>6.0884420910870762E-2</c:v>
                  </c:pt>
                  <c:pt idx="3">
                    <c:v>0.11683682993275432</c:v>
                  </c:pt>
                  <c:pt idx="4">
                    <c:v>0.14608187264307468</c:v>
                  </c:pt>
                </c:numCache>
              </c:numRef>
            </c:plus>
          </c:errBars>
          <c:cat>
            <c:strRef>
              <c:f>Sheet1!$B$42:$F$42</c:f>
              <c:strCache>
                <c:ptCount val="5"/>
                <c:pt idx="0">
                  <c:v>pfaA</c:v>
                </c:pt>
                <c:pt idx="1">
                  <c:v>pfaB</c:v>
                </c:pt>
                <c:pt idx="2">
                  <c:v>pfaC</c:v>
                </c:pt>
                <c:pt idx="3">
                  <c:v>pfaD</c:v>
                </c:pt>
                <c:pt idx="4">
                  <c:v>pfaE</c:v>
                </c:pt>
              </c:strCache>
            </c:strRef>
          </c:cat>
          <c:val>
            <c:numRef>
              <c:f>Sheet1!$B$44:$F$44</c:f>
              <c:numCache>
                <c:formatCode>0.00_);[Red]\(0.00\)</c:formatCode>
                <c:ptCount val="5"/>
                <c:pt idx="0">
                  <c:v>4.0511083485413817</c:v>
                </c:pt>
                <c:pt idx="1">
                  <c:v>2.9904931311091607</c:v>
                </c:pt>
                <c:pt idx="2">
                  <c:v>1.5665287844950895</c:v>
                </c:pt>
                <c:pt idx="3">
                  <c:v>1.7624040185547802</c:v>
                </c:pt>
                <c:pt idx="4">
                  <c:v>1</c:v>
                </c:pt>
              </c:numCache>
            </c:numRef>
          </c:val>
        </c:ser>
        <c:ser>
          <c:idx val="2"/>
          <c:order val="2"/>
          <c:tx>
            <c:strRef>
              <c:f>Sheet1!$A$45</c:f>
              <c:strCache>
                <c:ptCount val="1"/>
                <c:pt idx="0">
                  <c:v>pDHA-pfaABCD+pfaE(EPA)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B$51:$F$51</c:f>
                <c:numCache>
                  <c:formatCode>General</c:formatCode>
                  <c:ptCount val="5"/>
                  <c:pt idx="0">
                    <c:v>0.41480236420865618</c:v>
                  </c:pt>
                  <c:pt idx="1">
                    <c:v>0.97666343714002313</c:v>
                  </c:pt>
                  <c:pt idx="2">
                    <c:v>0.60142007984483059</c:v>
                  </c:pt>
                  <c:pt idx="3">
                    <c:v>1.4282931112072499</c:v>
                  </c:pt>
                  <c:pt idx="4">
                    <c:v>0.86766358910907992</c:v>
                  </c:pt>
                </c:numCache>
              </c:numRef>
            </c:plus>
          </c:errBars>
          <c:cat>
            <c:strRef>
              <c:f>Sheet1!$B$42:$F$42</c:f>
              <c:strCache>
                <c:ptCount val="5"/>
                <c:pt idx="0">
                  <c:v>pfaA</c:v>
                </c:pt>
                <c:pt idx="1">
                  <c:v>pfaB</c:v>
                </c:pt>
                <c:pt idx="2">
                  <c:v>pfaC</c:v>
                </c:pt>
                <c:pt idx="3">
                  <c:v>pfaD</c:v>
                </c:pt>
                <c:pt idx="4">
                  <c:v>pfaE</c:v>
                </c:pt>
              </c:strCache>
            </c:strRef>
          </c:cat>
          <c:val>
            <c:numRef>
              <c:f>Sheet1!$B$45:$F$45</c:f>
              <c:numCache>
                <c:formatCode>0.00_);[Red]\(0.00\)</c:formatCode>
                <c:ptCount val="5"/>
                <c:pt idx="0">
                  <c:v>4.6864771253605673</c:v>
                </c:pt>
                <c:pt idx="1">
                  <c:v>5.3599759772092561</c:v>
                </c:pt>
                <c:pt idx="2">
                  <c:v>5.2139476034945114</c:v>
                </c:pt>
                <c:pt idx="3">
                  <c:v>9.9090449892035508</c:v>
                </c:pt>
                <c:pt idx="4">
                  <c:v>1.6135308076476877</c:v>
                </c:pt>
              </c:numCache>
            </c:numRef>
          </c:val>
        </c:ser>
        <c:ser>
          <c:idx val="3"/>
          <c:order val="3"/>
          <c:tx>
            <c:strRef>
              <c:f>Sheet1!$A$46</c:f>
              <c:strCache>
                <c:ptCount val="1"/>
                <c:pt idx="0">
                  <c:v>pDHA-pfaABCD+pfaE(ARA)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B$52:$F$52</c:f>
                <c:numCache>
                  <c:formatCode>General</c:formatCode>
                  <c:ptCount val="5"/>
                  <c:pt idx="0">
                    <c:v>1.3613038615417989</c:v>
                  </c:pt>
                  <c:pt idx="1">
                    <c:v>0.99509268460484424</c:v>
                  </c:pt>
                  <c:pt idx="2">
                    <c:v>0.28043027841632129</c:v>
                  </c:pt>
                  <c:pt idx="3">
                    <c:v>0.6961648337626487</c:v>
                  </c:pt>
                  <c:pt idx="4">
                    <c:v>6.3060961024606468E-2</c:v>
                  </c:pt>
                </c:numCache>
              </c:numRef>
            </c:plus>
          </c:errBars>
          <c:cat>
            <c:strRef>
              <c:f>Sheet1!$B$42:$F$42</c:f>
              <c:strCache>
                <c:ptCount val="5"/>
                <c:pt idx="0">
                  <c:v>pfaA</c:v>
                </c:pt>
                <c:pt idx="1">
                  <c:v>pfaB</c:v>
                </c:pt>
                <c:pt idx="2">
                  <c:v>pfaC</c:v>
                </c:pt>
                <c:pt idx="3">
                  <c:v>pfaD</c:v>
                </c:pt>
                <c:pt idx="4">
                  <c:v>pfaE</c:v>
                </c:pt>
              </c:strCache>
            </c:strRef>
          </c:cat>
          <c:val>
            <c:numRef>
              <c:f>Sheet1!$B$46:$F$46</c:f>
              <c:numCache>
                <c:formatCode>0.00_);[Red]\(0.00\)</c:formatCode>
                <c:ptCount val="5"/>
                <c:pt idx="0">
                  <c:v>2.5166291507484817</c:v>
                </c:pt>
                <c:pt idx="1">
                  <c:v>2.1592656611070726</c:v>
                </c:pt>
                <c:pt idx="2">
                  <c:v>1.1982941515182353</c:v>
                </c:pt>
                <c:pt idx="3">
                  <c:v>1.4922628747771531</c:v>
                </c:pt>
                <c:pt idx="4">
                  <c:v>1.044590833168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683328"/>
        <c:axId val="163693312"/>
      </c:barChart>
      <c:catAx>
        <c:axId val="163683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63693312"/>
        <c:crosses val="autoZero"/>
        <c:auto val="1"/>
        <c:lblAlgn val="ctr"/>
        <c:lblOffset val="100"/>
        <c:noMultiLvlLbl val="0"/>
      </c:catAx>
      <c:valAx>
        <c:axId val="163693312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crossAx val="1636833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2270975503062121"/>
          <c:y val="3.1639690871974373E-2"/>
          <c:w val="0.44117913385826785"/>
          <c:h val="0.21449839603382931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FB9EA9-8B1D-46BE-933D-DDA1204AAD3D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C61E29-8387-498C-8D42-4CFA2E7718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013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S1 Fig </a:t>
            </a:r>
            <a:r>
              <a:rPr lang="en-US" altLang="zh-CN" dirty="0" smtClean="0"/>
              <a:t>Quantitative real-time RT-PCR (</a:t>
            </a:r>
            <a:r>
              <a:rPr lang="en-US" altLang="zh-CN" dirty="0" err="1" smtClean="0"/>
              <a:t>qRT</a:t>
            </a:r>
            <a:r>
              <a:rPr lang="en-US" altLang="zh-CN" dirty="0" smtClean="0"/>
              <a:t>-PCR) for detecting the transcriptional level of </a:t>
            </a:r>
            <a:r>
              <a:rPr lang="en-US" altLang="zh-CN" i="1" dirty="0" err="1" smtClean="0"/>
              <a:t>pfa</a:t>
            </a:r>
            <a:r>
              <a:rPr lang="en-US" altLang="zh-CN" dirty="0" smtClean="0"/>
              <a:t> gene</a:t>
            </a:r>
            <a:r>
              <a:rPr lang="en-US" altLang="zh-CN" baseline="0" dirty="0" smtClean="0"/>
              <a:t> cluster</a:t>
            </a:r>
            <a:r>
              <a:rPr lang="en-US" altLang="zh-CN" dirty="0" smtClean="0"/>
              <a:t> in recombinant</a:t>
            </a:r>
            <a:r>
              <a:rPr lang="en-US" altLang="zh-CN" baseline="0" dirty="0" smtClean="0"/>
              <a:t> cells.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constitutively expressed 16S ribosomal RNA gene was used as an internal </a:t>
            </a:r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rol.</a:t>
            </a:r>
            <a:r>
              <a:rPr lang="en-US" altLang="zh-CN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 experiments were performed in triplicate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4B4A5D-5F7E-4056-95F3-CE1F708C2656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51604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4E2FB-3F2C-466D-AA88-03762DE1448E}" type="datetimeFigureOut">
              <a:rPr lang="zh-CN" altLang="en-US" smtClean="0"/>
              <a:t>2016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8C4EC-6272-44FB-91D7-3749EFB356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3"/>
          <p:cNvGrpSpPr/>
          <p:nvPr/>
        </p:nvGrpSpPr>
        <p:grpSpPr>
          <a:xfrm>
            <a:off x="2227726" y="2057400"/>
            <a:ext cx="4630274" cy="2743200"/>
            <a:chOff x="2227726" y="2057400"/>
            <a:chExt cx="4630274" cy="2743200"/>
          </a:xfrm>
        </p:grpSpPr>
        <p:sp>
          <p:nvSpPr>
            <p:cNvPr id="2" name="TextBox 1"/>
            <p:cNvSpPr txBox="1"/>
            <p:nvPr/>
          </p:nvSpPr>
          <p:spPr>
            <a:xfrm rot="10800000">
              <a:off x="2227726" y="2780928"/>
              <a:ext cx="369332" cy="14747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 smtClean="0"/>
                <a:t>Gene expression level </a:t>
              </a:r>
              <a:endParaRPr lang="zh-CN" altLang="en-US" sz="1200" dirty="0"/>
            </a:p>
          </p:txBody>
        </p:sp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7185197"/>
                </p:ext>
              </p:extLst>
            </p:nvPr>
          </p:nvGraphicFramePr>
          <p:xfrm>
            <a:off x="2286000" y="2057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138425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46</Words>
  <Application>Microsoft Office PowerPoint</Application>
  <PresentationFormat>全屏显示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国农业科学院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tpengyunfeng</dc:creator>
  <cp:lastModifiedBy>wx</cp:lastModifiedBy>
  <cp:revision>4</cp:revision>
  <dcterms:created xsi:type="dcterms:W3CDTF">2016-04-18T10:02:14Z</dcterms:created>
  <dcterms:modified xsi:type="dcterms:W3CDTF">2016-07-28T05:15:41Z</dcterms:modified>
</cp:coreProperties>
</file>